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8.jpeg" ContentType="image/jpeg"/>
  <Override PartName="/ppt/media/image25.png" ContentType="image/png"/>
  <Override PartName="/ppt/media/image19.jpeg" ContentType="image/jpeg"/>
  <Override PartName="/ppt/media/image10.jpeg" ContentType="image/jpeg"/>
  <Override PartName="/ppt/media/image29.jpeg" ContentType="image/jpeg"/>
  <Override PartName="/ppt/media/image30.png" ContentType="image/png"/>
  <Override PartName="/ppt/media/image6.png" ContentType="image/png"/>
  <Override PartName="/ppt/media/image31.png" ContentType="image/png"/>
  <Override PartName="/ppt/media/image22.jpeg" ContentType="image/jpeg"/>
  <Override PartName="/ppt/media/image1.jpeg" ContentType="image/jpeg"/>
  <Override PartName="/ppt/media/image7.png" ContentType="image/png"/>
  <Override PartName="/ppt/media/image32.png" ContentType="image/png"/>
  <Override PartName="/ppt/media/image8.png" ContentType="image/png"/>
  <Override PartName="/ppt/media/image14.jpeg" ContentType="image/jpeg"/>
  <Override PartName="/ppt/media/image11.jpeg" ContentType="image/jpeg"/>
  <Override PartName="/ppt/media/image9.jpeg" ContentType="image/jpeg"/>
  <Override PartName="/ppt/media/image5.jpeg" ContentType="image/jpeg"/>
  <Override PartName="/ppt/media/image26.jpeg" ContentType="image/jpeg"/>
  <Override PartName="/ppt/media/image13.jpeg" ContentType="image/jpeg"/>
  <Override PartName="/ppt/media/image12.jpeg" ContentType="image/jpeg"/>
  <Override PartName="/ppt/media/image4.png" ContentType="image/png"/>
  <Override PartName="/ppt/media/image27.png" ContentType="image/png"/>
  <Override PartName="/ppt/media/image3.png" ContentType="image/png"/>
  <Override PartName="/ppt/media/image17.jpeg" ContentType="image/jpeg"/>
  <Override PartName="/ppt/media/image2.jpeg" ContentType="image/jpeg"/>
  <Override PartName="/ppt/media/image23.jpeg" ContentType="image/jpeg"/>
  <Override PartName="/ppt/media/image15.jpeg" ContentType="image/jpeg"/>
  <Override PartName="/ppt/media/image16.jpeg" ContentType="image/jpeg"/>
  <Override PartName="/ppt/media/image18.jpeg" ContentType="image/jpeg"/>
  <Override PartName="/ppt/media/image20.jpeg" ContentType="image/jpeg"/>
  <Override PartName="/ppt/media/image21.jpeg" ContentType="image/jpeg"/>
  <Override PartName="/ppt/media/image2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E27E05-B1C4-48DB-9970-6938F921D8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41676-8CEC-4535-A2F6-ABA7122C98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FA5CD-EA30-4120-BAB2-E97499B0A9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9C372-D9BF-487D-A42E-FB3EEA3706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E143C-4D5F-4FC9-8068-1DF8E94DF9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816AD-457E-4A39-B9DB-5C59C014B8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18FB3-2D5C-46E1-AF05-EFE2E4339A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FA9EC-FE96-483C-89E9-BD26575468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7E9CE-3AB7-49AA-B8C8-2BE64113F4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789AF2-7F6F-40E0-BE25-ADB5B9597E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28EE7-F21A-44E8-B98B-D6347BB548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A20AA-356A-407C-B2BF-BF346589A1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EFC927-79A5-41C8-8CDE-A7B5E69337D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image" Target="../media/image19.jpeg"/><Relationship Id="rId4" Type="http://schemas.openxmlformats.org/officeDocument/2006/relationships/image" Target="../media/image20.jpeg"/><Relationship Id="rId5" Type="http://schemas.openxmlformats.org/officeDocument/2006/relationships/image" Target="../media/image21.jpeg"/><Relationship Id="rId6" Type="http://schemas.openxmlformats.org/officeDocument/2006/relationships/image" Target="../media/image22.jpeg"/><Relationship Id="rId7" Type="http://schemas.openxmlformats.org/officeDocument/2006/relationships/image" Target="../media/image23.jpeg"/><Relationship Id="rId8" Type="http://schemas.openxmlformats.org/officeDocument/2006/relationships/image" Target="../media/image24.jpeg"/><Relationship Id="rId9" Type="http://schemas.openxmlformats.org/officeDocument/2006/relationships/image" Target="../media/image25.png"/><Relationship Id="rId10" Type="http://schemas.openxmlformats.org/officeDocument/2006/relationships/image" Target="../media/image26.jpeg"/><Relationship Id="rId11" Type="http://schemas.openxmlformats.org/officeDocument/2006/relationships/image" Target="../media/image27.png"/><Relationship Id="rId12" Type="http://schemas.openxmlformats.org/officeDocument/2006/relationships/image" Target="../media/image28.jpeg"/><Relationship Id="rId13" Type="http://schemas.openxmlformats.org/officeDocument/2006/relationships/image" Target="../media/image29.jpeg"/><Relationship Id="rId14" Type="http://schemas.openxmlformats.org/officeDocument/2006/relationships/image" Target="../media/image30.png"/><Relationship Id="rId15" Type="http://schemas.openxmlformats.org/officeDocument/2006/relationships/image" Target="../media/image31.png"/><Relationship Id="rId16" Type="http://schemas.openxmlformats.org/officeDocument/2006/relationships/image" Target="../media/image32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15"/>
          <p:cNvSpPr/>
          <p:nvPr/>
        </p:nvSpPr>
        <p:spPr>
          <a:xfrm>
            <a:off x="333000" y="227160"/>
            <a:ext cx="30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30"/>
          <p:cNvGrpSpPr/>
          <p:nvPr/>
        </p:nvGrpSpPr>
        <p:grpSpPr>
          <a:xfrm>
            <a:off x="5169240" y="2270160"/>
            <a:ext cx="4465440" cy="2166480"/>
            <a:chOff x="5169240" y="2270160"/>
            <a:chExt cx="4465440" cy="2166480"/>
          </a:xfrm>
        </p:grpSpPr>
        <p:pic>
          <p:nvPicPr>
            <p:cNvPr id="43" name="Picture 73" descr="D:\Dr. kojima in chiba\kojima_invasion\PC3, DU145_miR-1, 133a_si-PNP_invasion\3.5.11_PC3_mock, miR-1, 133a, siC, siPNP-1, siPNP-3_invasion\P1010005.TIF"/>
            <p:cNvPicPr/>
            <p:nvPr/>
          </p:nvPicPr>
          <p:blipFill>
            <a:blip r:embed="rId1"/>
            <a:stretch/>
          </p:blipFill>
          <p:spPr>
            <a:xfrm>
              <a:off x="5961240" y="2709360"/>
              <a:ext cx="865080" cy="783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74" descr="D:\Dr. kojima in chiba\kojima_invasion\PC3, DU145_miR-1, 133a_si-PNP_invasion\3.5.11_PC3_mock, miR-1, 133a, siC, siPNP-1, siPNP-3_invasion\P1010034.TIF"/>
            <p:cNvPicPr/>
            <p:nvPr/>
          </p:nvPicPr>
          <p:blipFill>
            <a:blip r:embed="rId2"/>
            <a:stretch/>
          </p:blipFill>
          <p:spPr>
            <a:xfrm>
              <a:off x="6899400" y="2710800"/>
              <a:ext cx="863640" cy="78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75" descr="D:\Dr. kojima in chiba\kojima_invasion\PC3, DU145_miR-1, 133a_si-PNP_invasion\3.5.11_PC3_mock, miR-1, 133a, siC, siPNP-1, siPNP-3_invasion\P1010046.TIF"/>
            <p:cNvPicPr/>
            <p:nvPr/>
          </p:nvPicPr>
          <p:blipFill>
            <a:blip r:embed="rId3"/>
            <a:stretch/>
          </p:blipFill>
          <p:spPr>
            <a:xfrm>
              <a:off x="7839000" y="2710800"/>
              <a:ext cx="863640" cy="78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76" descr="D:\Dr. kojima in chiba\kojima_invasion\PC3, DU145_miR-1, 133a_si-PNP_invasion\3.5.11_PC3_mock, miR-1, 133a, siC, siPNP-1, siPNP-3_invasion\P1010052.TIF"/>
            <p:cNvPicPr/>
            <p:nvPr/>
          </p:nvPicPr>
          <p:blipFill>
            <a:blip r:embed="rId4"/>
            <a:stretch/>
          </p:blipFill>
          <p:spPr>
            <a:xfrm>
              <a:off x="8771040" y="2710800"/>
              <a:ext cx="863640" cy="78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77" descr="D:\Dr. kojima in chiba\kojima_invasion\PC3, DU145_miR-1, 133a_si-PNP_invasion\3.6.11_DU145_mock, miR-1, 133a, siC, siPNP-1, siPNP-3_invasion\P1010002.TIF"/>
            <p:cNvPicPr/>
            <p:nvPr/>
          </p:nvPicPr>
          <p:blipFill>
            <a:blip r:embed="rId5"/>
            <a:stretch/>
          </p:blipFill>
          <p:spPr>
            <a:xfrm>
              <a:off x="5964120" y="3572280"/>
              <a:ext cx="863640" cy="86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79" descr="D:\Dr. kojima in chiba\kojima_invasion\PC3, DU145_miR-1, 133a_si-PNP_invasion\3.6.11_DU145_mock, miR-1, 133a, siC, siPNP-1, siPNP-3_invasion\P1010023.TIF"/>
            <p:cNvPicPr/>
            <p:nvPr/>
          </p:nvPicPr>
          <p:blipFill>
            <a:blip r:embed="rId6"/>
            <a:stretch/>
          </p:blipFill>
          <p:spPr>
            <a:xfrm>
              <a:off x="7842240" y="3572280"/>
              <a:ext cx="857160" cy="85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80" descr="D:\Dr. kojima in chiba\kojima_invasion\PC3, DU145_miR-1, 133a_si-PNP_invasion\3.6.11_DU145_mock, miR-1, 133a, siC, siPNP-1, siPNP-3_invasion\P1010026.TIF"/>
            <p:cNvPicPr/>
            <p:nvPr/>
          </p:nvPicPr>
          <p:blipFill>
            <a:blip r:embed="rId7"/>
            <a:stretch/>
          </p:blipFill>
          <p:spPr>
            <a:xfrm>
              <a:off x="8771040" y="3572280"/>
              <a:ext cx="863640" cy="86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Rectangle 405"/>
            <p:cNvSpPr/>
            <p:nvPr/>
          </p:nvSpPr>
          <p:spPr>
            <a:xfrm>
              <a:off x="5961240" y="2709360"/>
              <a:ext cx="3673440" cy="1727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327"/>
            <p:cNvSpPr/>
            <p:nvPr/>
          </p:nvSpPr>
          <p:spPr>
            <a:xfrm>
              <a:off x="5413320" y="3065040"/>
              <a:ext cx="366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C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30"/>
            <p:cNvSpPr/>
            <p:nvPr/>
          </p:nvSpPr>
          <p:spPr>
            <a:xfrm>
              <a:off x="5169240" y="3927960"/>
              <a:ext cx="610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DU1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36"/>
            <p:cNvSpPr/>
            <p:nvPr/>
          </p:nvSpPr>
          <p:spPr>
            <a:xfrm>
              <a:off x="8774640" y="237960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133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442"/>
            <p:cNvSpPr/>
            <p:nvPr/>
          </p:nvSpPr>
          <p:spPr>
            <a:xfrm>
              <a:off x="7998840" y="2379600"/>
              <a:ext cx="534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48"/>
            <p:cNvSpPr/>
            <p:nvPr/>
          </p:nvSpPr>
          <p:spPr>
            <a:xfrm>
              <a:off x="6952680" y="2270160"/>
              <a:ext cx="74736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</a:t>
              </a:r>
              <a:br>
                <a:rPr sz="1400"/>
              </a:b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48"/>
            <p:cNvSpPr/>
            <p:nvPr/>
          </p:nvSpPr>
          <p:spPr>
            <a:xfrm>
              <a:off x="6177600" y="2379600"/>
              <a:ext cx="427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76" descr="D:\Dr. kojima in chiba\kojima_invasion\PC3, DU145_miR-1, 133a_si-PNP_invasion\3.6.11_DU145_mock, miR-1, 133a, siC, siPNP-1, siPNP-3_invasion - コピー\3.6.11_DU145_miR-C2_8.TIF"/>
            <p:cNvPicPr/>
            <p:nvPr/>
          </p:nvPicPr>
          <p:blipFill>
            <a:blip r:embed="rId8"/>
            <a:stretch/>
          </p:blipFill>
          <p:spPr>
            <a:xfrm>
              <a:off x="6897600" y="3580200"/>
              <a:ext cx="863640" cy="856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8" name="Group 450"/>
          <p:cNvGrpSpPr/>
          <p:nvPr/>
        </p:nvGrpSpPr>
        <p:grpSpPr>
          <a:xfrm>
            <a:off x="273240" y="2225520"/>
            <a:ext cx="4466160" cy="2210040"/>
            <a:chOff x="273240" y="2225520"/>
            <a:chExt cx="4466160" cy="2210040"/>
          </a:xfrm>
        </p:grpSpPr>
        <p:grpSp>
          <p:nvGrpSpPr>
            <p:cNvPr id="59" name="Group 276"/>
            <p:cNvGrpSpPr/>
            <p:nvPr/>
          </p:nvGrpSpPr>
          <p:grpSpPr>
            <a:xfrm>
              <a:off x="1065240" y="3594240"/>
              <a:ext cx="3673440" cy="841320"/>
              <a:chOff x="1065240" y="3594240"/>
              <a:chExt cx="3673440" cy="841320"/>
            </a:xfrm>
          </p:grpSpPr>
          <p:pic>
            <p:nvPicPr>
              <p:cNvPr id="60" name="Picture 4" descr=""/>
              <p:cNvPicPr/>
              <p:nvPr/>
            </p:nvPicPr>
            <p:blipFill>
              <a:blip r:embed="rId9"/>
              <a:stretch/>
            </p:blipFill>
            <p:spPr>
              <a:xfrm>
                <a:off x="1065240" y="3594240"/>
                <a:ext cx="897120" cy="8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1" name="直線コネクタ 460"/>
              <p:cNvSpPr/>
              <p:nvPr/>
            </p:nvSpPr>
            <p:spPr>
              <a:xfrm>
                <a:off x="1397160" y="3721320"/>
                <a:ext cx="223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直線コネクタ 461"/>
              <p:cNvSpPr/>
              <p:nvPr/>
            </p:nvSpPr>
            <p:spPr>
              <a:xfrm flipH="1">
                <a:off x="1417320" y="3907080"/>
                <a:ext cx="16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直線コネクタ 462"/>
              <p:cNvSpPr/>
              <p:nvPr/>
            </p:nvSpPr>
            <p:spPr>
              <a:xfrm flipH="1">
                <a:off x="1427400" y="4134240"/>
                <a:ext cx="118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直線コネクタ 463"/>
              <p:cNvSpPr/>
              <p:nvPr/>
            </p:nvSpPr>
            <p:spPr>
              <a:xfrm flipH="1">
                <a:off x="1396800" y="4335840"/>
                <a:ext cx="19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5" name="Picture 4" descr=""/>
              <p:cNvPicPr/>
              <p:nvPr/>
            </p:nvPicPr>
            <p:blipFill>
              <a:blip r:embed="rId10"/>
              <a:stretch/>
            </p:blipFill>
            <p:spPr>
              <a:xfrm>
                <a:off x="1989360" y="3594240"/>
                <a:ext cx="898560" cy="8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直線コネクタ 472"/>
              <p:cNvSpPr/>
              <p:nvPr/>
            </p:nvSpPr>
            <p:spPr>
              <a:xfrm>
                <a:off x="2438640" y="3721320"/>
                <a:ext cx="16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直線コネクタ 473"/>
              <p:cNvSpPr/>
              <p:nvPr/>
            </p:nvSpPr>
            <p:spPr>
              <a:xfrm flipH="1">
                <a:off x="2438280" y="3907080"/>
                <a:ext cx="16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直線コネクタ 474"/>
              <p:cNvSpPr/>
              <p:nvPr/>
            </p:nvSpPr>
            <p:spPr>
              <a:xfrm flipH="1">
                <a:off x="2395440" y="4134240"/>
                <a:ext cx="16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直線コネクタ 475"/>
              <p:cNvSpPr/>
              <p:nvPr/>
            </p:nvSpPr>
            <p:spPr>
              <a:xfrm flipH="1">
                <a:off x="2406240" y="4335840"/>
                <a:ext cx="203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0" name="Picture 4" descr=""/>
              <p:cNvPicPr/>
              <p:nvPr/>
            </p:nvPicPr>
            <p:blipFill>
              <a:blip r:embed="rId11"/>
              <a:stretch/>
            </p:blipFill>
            <p:spPr>
              <a:xfrm>
                <a:off x="2914560" y="3594240"/>
                <a:ext cx="898560" cy="8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" name="直線コネクタ 478"/>
              <p:cNvSpPr/>
              <p:nvPr/>
            </p:nvSpPr>
            <p:spPr>
              <a:xfrm>
                <a:off x="3181320" y="3721320"/>
                <a:ext cx="376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直線コネクタ 479"/>
              <p:cNvSpPr/>
              <p:nvPr/>
            </p:nvSpPr>
            <p:spPr>
              <a:xfrm flipH="1">
                <a:off x="3160440" y="3907080"/>
                <a:ext cx="353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直線コネクタ 480"/>
              <p:cNvSpPr/>
              <p:nvPr/>
            </p:nvSpPr>
            <p:spPr>
              <a:xfrm flipH="1">
                <a:off x="3181320" y="4134240"/>
                <a:ext cx="333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直線コネクタ 481"/>
              <p:cNvSpPr/>
              <p:nvPr/>
            </p:nvSpPr>
            <p:spPr>
              <a:xfrm flipH="1">
                <a:off x="3192120" y="4335840"/>
                <a:ext cx="343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5" name="Picture 4" descr=""/>
              <p:cNvPicPr/>
              <p:nvPr/>
            </p:nvPicPr>
            <p:blipFill>
              <a:blip r:embed="rId12"/>
              <a:stretch/>
            </p:blipFill>
            <p:spPr>
              <a:xfrm>
                <a:off x="3841920" y="3594240"/>
                <a:ext cx="896760" cy="8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6" name="直線コネクタ 484"/>
              <p:cNvSpPr/>
              <p:nvPr/>
            </p:nvSpPr>
            <p:spPr>
              <a:xfrm>
                <a:off x="4140360" y="3721320"/>
                <a:ext cx="257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直線コネクタ 485"/>
              <p:cNvSpPr/>
              <p:nvPr/>
            </p:nvSpPr>
            <p:spPr>
              <a:xfrm flipH="1">
                <a:off x="4119480" y="3907080"/>
                <a:ext cx="309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直線コネクタ 486"/>
              <p:cNvSpPr/>
              <p:nvPr/>
            </p:nvSpPr>
            <p:spPr>
              <a:xfrm flipH="1">
                <a:off x="4183200" y="413424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直線コネクタ 487"/>
              <p:cNvSpPr/>
              <p:nvPr/>
            </p:nvSpPr>
            <p:spPr>
              <a:xfrm flipH="1">
                <a:off x="4162680" y="4335840"/>
                <a:ext cx="23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" name="Rectangle 327"/>
            <p:cNvSpPr/>
            <p:nvPr/>
          </p:nvSpPr>
          <p:spPr>
            <a:xfrm>
              <a:off x="517680" y="3066840"/>
              <a:ext cx="366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C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330"/>
            <p:cNvSpPr/>
            <p:nvPr/>
          </p:nvSpPr>
          <p:spPr>
            <a:xfrm>
              <a:off x="273240" y="3930480"/>
              <a:ext cx="610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DU1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36"/>
            <p:cNvSpPr/>
            <p:nvPr/>
          </p:nvSpPr>
          <p:spPr>
            <a:xfrm>
              <a:off x="3885120" y="233532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133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42"/>
            <p:cNvSpPr/>
            <p:nvPr/>
          </p:nvSpPr>
          <p:spPr>
            <a:xfrm>
              <a:off x="3103200" y="2335320"/>
              <a:ext cx="534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48"/>
            <p:cNvSpPr/>
            <p:nvPr/>
          </p:nvSpPr>
          <p:spPr>
            <a:xfrm>
              <a:off x="2079000" y="2225520"/>
              <a:ext cx="74736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iR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48"/>
            <p:cNvSpPr/>
            <p:nvPr/>
          </p:nvSpPr>
          <p:spPr>
            <a:xfrm>
              <a:off x="1251720" y="2335320"/>
              <a:ext cx="427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Group 275"/>
            <p:cNvGrpSpPr/>
            <p:nvPr/>
          </p:nvGrpSpPr>
          <p:grpSpPr>
            <a:xfrm>
              <a:off x="1065240" y="2706480"/>
              <a:ext cx="3673440" cy="841320"/>
              <a:chOff x="1065240" y="2706480"/>
              <a:chExt cx="3673440" cy="841320"/>
            </a:xfrm>
          </p:grpSpPr>
          <p:pic>
            <p:nvPicPr>
              <p:cNvPr id="87" name="Picture 4" descr=""/>
              <p:cNvPicPr/>
              <p:nvPr/>
            </p:nvPicPr>
            <p:blipFill>
              <a:blip r:embed="rId13"/>
              <a:stretch/>
            </p:blipFill>
            <p:spPr>
              <a:xfrm>
                <a:off x="1065240" y="2706480"/>
                <a:ext cx="897120" cy="841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" name="直線コネクタ 432"/>
              <p:cNvSpPr/>
              <p:nvPr/>
            </p:nvSpPr>
            <p:spPr>
              <a:xfrm>
                <a:off x="1417680" y="2819160"/>
                <a:ext cx="12852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直線コネクタ 433"/>
              <p:cNvSpPr/>
              <p:nvPr/>
            </p:nvSpPr>
            <p:spPr>
              <a:xfrm flipH="1">
                <a:off x="1427400" y="3019320"/>
                <a:ext cx="8568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直線コネクタ 434"/>
              <p:cNvSpPr/>
              <p:nvPr/>
            </p:nvSpPr>
            <p:spPr>
              <a:xfrm flipH="1">
                <a:off x="1406520" y="3233520"/>
                <a:ext cx="10656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直線コネクタ 435"/>
              <p:cNvSpPr/>
              <p:nvPr/>
            </p:nvSpPr>
            <p:spPr>
              <a:xfrm flipH="1">
                <a:off x="1438200" y="3421080"/>
                <a:ext cx="128880" cy="0"/>
              </a:xfrm>
              <a:prstGeom prst="line">
                <a:avLst/>
              </a:prstGeom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2" name="グループ化 445"/>
              <p:cNvGrpSpPr/>
              <p:nvPr/>
            </p:nvGrpSpPr>
            <p:grpSpPr>
              <a:xfrm>
                <a:off x="1990800" y="2708280"/>
                <a:ext cx="897120" cy="839520"/>
                <a:chOff x="1990800" y="2708280"/>
                <a:chExt cx="897120" cy="839520"/>
              </a:xfrm>
            </p:grpSpPr>
            <p:pic>
              <p:nvPicPr>
                <p:cNvPr id="93" name="Picture 4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1990800" y="2708280"/>
                  <a:ext cx="897120" cy="839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4" name="直線コネクタ 441"/>
                <p:cNvSpPr/>
                <p:nvPr/>
              </p:nvSpPr>
              <p:spPr>
                <a:xfrm>
                  <a:off x="2374920" y="2833200"/>
                  <a:ext cx="13968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直線コネクタ 442"/>
                <p:cNvSpPr/>
                <p:nvPr/>
              </p:nvSpPr>
              <p:spPr>
                <a:xfrm flipH="1">
                  <a:off x="2406600" y="3034800"/>
                  <a:ext cx="9684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直線コネクタ 443"/>
                <p:cNvSpPr/>
                <p:nvPr/>
              </p:nvSpPr>
              <p:spPr>
                <a:xfrm flipH="1">
                  <a:off x="2364120" y="3275280"/>
                  <a:ext cx="12888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直線コネクタ 444"/>
                <p:cNvSpPr/>
                <p:nvPr/>
              </p:nvSpPr>
              <p:spPr>
                <a:xfrm flipH="1">
                  <a:off x="2396160" y="3448440"/>
                  <a:ext cx="10728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8" name="グループ化 451"/>
              <p:cNvGrpSpPr/>
              <p:nvPr/>
            </p:nvGrpSpPr>
            <p:grpSpPr>
              <a:xfrm>
                <a:off x="2916360" y="2708280"/>
                <a:ext cx="896760" cy="839520"/>
                <a:chOff x="2916360" y="2708280"/>
                <a:chExt cx="896760" cy="839520"/>
              </a:xfrm>
            </p:grpSpPr>
            <p:pic>
              <p:nvPicPr>
                <p:cNvPr id="99" name="Picture 4" descr="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2916360" y="2708280"/>
                  <a:ext cx="896760" cy="839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0" name="直線コネクタ 447"/>
                <p:cNvSpPr/>
                <p:nvPr/>
              </p:nvSpPr>
              <p:spPr>
                <a:xfrm>
                  <a:off x="3193560" y="2833200"/>
                  <a:ext cx="3528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直線コネクタ 448"/>
                <p:cNvSpPr/>
                <p:nvPr/>
              </p:nvSpPr>
              <p:spPr>
                <a:xfrm flipH="1">
                  <a:off x="3204360" y="3034800"/>
                  <a:ext cx="3420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直線コネクタ 449"/>
                <p:cNvSpPr/>
                <p:nvPr/>
              </p:nvSpPr>
              <p:spPr>
                <a:xfrm flipH="1">
                  <a:off x="3171960" y="3275280"/>
                  <a:ext cx="42804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直線コネクタ 450"/>
                <p:cNvSpPr/>
                <p:nvPr/>
              </p:nvSpPr>
              <p:spPr>
                <a:xfrm flipH="1">
                  <a:off x="3193560" y="3448440"/>
                  <a:ext cx="3312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4" name="グループ化 458"/>
              <p:cNvGrpSpPr/>
              <p:nvPr/>
            </p:nvGrpSpPr>
            <p:grpSpPr>
              <a:xfrm>
                <a:off x="3841920" y="2708280"/>
                <a:ext cx="896760" cy="839520"/>
                <a:chOff x="3841920" y="2708280"/>
                <a:chExt cx="896760" cy="839520"/>
              </a:xfrm>
            </p:grpSpPr>
            <p:pic>
              <p:nvPicPr>
                <p:cNvPr id="105" name="Picture 4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3841920" y="2708280"/>
                  <a:ext cx="896760" cy="839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6" name="直線コネクタ 453"/>
                <p:cNvSpPr/>
                <p:nvPr/>
              </p:nvSpPr>
              <p:spPr>
                <a:xfrm>
                  <a:off x="4162320" y="2833200"/>
                  <a:ext cx="3096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直線コネクタ 454"/>
                <p:cNvSpPr/>
                <p:nvPr/>
              </p:nvSpPr>
              <p:spPr>
                <a:xfrm flipH="1">
                  <a:off x="4162320" y="3034800"/>
                  <a:ext cx="2772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直線コネクタ 455"/>
                <p:cNvSpPr/>
                <p:nvPr/>
              </p:nvSpPr>
              <p:spPr>
                <a:xfrm flipH="1">
                  <a:off x="4119120" y="3275280"/>
                  <a:ext cx="3204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直線コネクタ 456"/>
                <p:cNvSpPr/>
                <p:nvPr/>
              </p:nvSpPr>
              <p:spPr>
                <a:xfrm flipH="1">
                  <a:off x="4140720" y="3448440"/>
                  <a:ext cx="331200" cy="0"/>
                </a:xfrm>
                <a:prstGeom prst="line">
                  <a:avLst/>
                </a:prstGeom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0" name="Rectangle 280"/>
            <p:cNvSpPr/>
            <p:nvPr/>
          </p:nvSpPr>
          <p:spPr>
            <a:xfrm>
              <a:off x="1065240" y="2706480"/>
              <a:ext cx="3673440" cy="17290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431"/>
            <p:cNvSpPr/>
            <p:nvPr/>
          </p:nvSpPr>
          <p:spPr>
            <a:xfrm>
              <a:off x="1352520" y="342900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434"/>
            <p:cNvSpPr/>
            <p:nvPr/>
          </p:nvSpPr>
          <p:spPr>
            <a:xfrm>
              <a:off x="1352520" y="285264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435"/>
            <p:cNvSpPr/>
            <p:nvPr/>
          </p:nvSpPr>
          <p:spPr>
            <a:xfrm>
              <a:off x="1424160" y="3139920"/>
              <a:ext cx="21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436"/>
            <p:cNvSpPr/>
            <p:nvPr/>
          </p:nvSpPr>
          <p:spPr>
            <a:xfrm>
              <a:off x="1352520" y="328464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437"/>
            <p:cNvSpPr/>
            <p:nvPr/>
          </p:nvSpPr>
          <p:spPr>
            <a:xfrm>
              <a:off x="2360520" y="2779560"/>
              <a:ext cx="1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438"/>
            <p:cNvSpPr/>
            <p:nvPr/>
          </p:nvSpPr>
          <p:spPr>
            <a:xfrm>
              <a:off x="2360520" y="2997000"/>
              <a:ext cx="1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439"/>
            <p:cNvSpPr/>
            <p:nvPr/>
          </p:nvSpPr>
          <p:spPr>
            <a:xfrm>
              <a:off x="2360520" y="3213000"/>
              <a:ext cx="1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440"/>
            <p:cNvSpPr/>
            <p:nvPr/>
          </p:nvSpPr>
          <p:spPr>
            <a:xfrm>
              <a:off x="2360520" y="3429000"/>
              <a:ext cx="14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441"/>
            <p:cNvSpPr/>
            <p:nvPr/>
          </p:nvSpPr>
          <p:spPr>
            <a:xfrm>
              <a:off x="3152880" y="285264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442"/>
            <p:cNvSpPr/>
            <p:nvPr/>
          </p:nvSpPr>
          <p:spPr>
            <a:xfrm>
              <a:off x="3152880" y="30686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443"/>
            <p:cNvSpPr/>
            <p:nvPr/>
          </p:nvSpPr>
          <p:spPr>
            <a:xfrm>
              <a:off x="3152880" y="32846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444"/>
            <p:cNvSpPr/>
            <p:nvPr/>
          </p:nvSpPr>
          <p:spPr>
            <a:xfrm>
              <a:off x="3152880" y="342900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445"/>
            <p:cNvSpPr/>
            <p:nvPr/>
          </p:nvSpPr>
          <p:spPr>
            <a:xfrm>
              <a:off x="4160880" y="277956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446"/>
            <p:cNvSpPr/>
            <p:nvPr/>
          </p:nvSpPr>
          <p:spPr>
            <a:xfrm>
              <a:off x="4160880" y="313992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447"/>
            <p:cNvSpPr/>
            <p:nvPr/>
          </p:nvSpPr>
          <p:spPr>
            <a:xfrm>
              <a:off x="4160880" y="335592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449"/>
            <p:cNvSpPr/>
            <p:nvPr/>
          </p:nvSpPr>
          <p:spPr>
            <a:xfrm>
              <a:off x="4160880" y="2924280"/>
              <a:ext cx="28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7" name="Text Box 197"/>
          <p:cNvSpPr/>
          <p:nvPr/>
        </p:nvSpPr>
        <p:spPr>
          <a:xfrm>
            <a:off x="277560" y="183816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197"/>
          <p:cNvSpPr/>
          <p:nvPr/>
        </p:nvSpPr>
        <p:spPr>
          <a:xfrm>
            <a:off x="5146560" y="183816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 Box 194"/>
          <p:cNvSpPr/>
          <p:nvPr/>
        </p:nvSpPr>
        <p:spPr>
          <a:xfrm>
            <a:off x="333000" y="227160"/>
            <a:ext cx="30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Supplemental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319"/>
          <p:cNvGrpSpPr/>
          <p:nvPr/>
        </p:nvGrpSpPr>
        <p:grpSpPr>
          <a:xfrm>
            <a:off x="273240" y="2192400"/>
            <a:ext cx="4470120" cy="2314080"/>
            <a:chOff x="273240" y="2192400"/>
            <a:chExt cx="4470120" cy="2314080"/>
          </a:xfrm>
        </p:grpSpPr>
        <p:sp>
          <p:nvSpPr>
            <p:cNvPr id="131" name="Rectangle 327"/>
            <p:cNvSpPr/>
            <p:nvPr/>
          </p:nvSpPr>
          <p:spPr>
            <a:xfrm>
              <a:off x="517680" y="2994840"/>
              <a:ext cx="366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C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330"/>
            <p:cNvSpPr/>
            <p:nvPr/>
          </p:nvSpPr>
          <p:spPr>
            <a:xfrm>
              <a:off x="273240" y="3857760"/>
              <a:ext cx="610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DU1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436"/>
            <p:cNvSpPr/>
            <p:nvPr/>
          </p:nvSpPr>
          <p:spPr>
            <a:xfrm>
              <a:off x="3885120" y="230004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NP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442"/>
            <p:cNvSpPr/>
            <p:nvPr/>
          </p:nvSpPr>
          <p:spPr>
            <a:xfrm>
              <a:off x="2953440" y="230004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NP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448"/>
            <p:cNvSpPr/>
            <p:nvPr/>
          </p:nvSpPr>
          <p:spPr>
            <a:xfrm>
              <a:off x="2093400" y="2192400"/>
              <a:ext cx="74736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br>
                <a:rPr sz="1400"/>
              </a:b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448"/>
            <p:cNvSpPr/>
            <p:nvPr/>
          </p:nvSpPr>
          <p:spPr>
            <a:xfrm>
              <a:off x="1304280" y="2301480"/>
              <a:ext cx="427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" name="Group 200"/>
            <p:cNvGrpSpPr/>
            <p:nvPr/>
          </p:nvGrpSpPr>
          <p:grpSpPr>
            <a:xfrm>
              <a:off x="1065240" y="2636640"/>
              <a:ext cx="3678120" cy="886680"/>
              <a:chOff x="1065240" y="2636640"/>
              <a:chExt cx="3678120" cy="886680"/>
            </a:xfrm>
          </p:grpSpPr>
          <p:grpSp>
            <p:nvGrpSpPr>
              <p:cNvPr id="138" name="グループ化 440"/>
              <p:cNvGrpSpPr/>
              <p:nvPr/>
            </p:nvGrpSpPr>
            <p:grpSpPr>
              <a:xfrm>
                <a:off x="1065240" y="2636640"/>
                <a:ext cx="900360" cy="886680"/>
                <a:chOff x="1065240" y="2636640"/>
                <a:chExt cx="900360" cy="886680"/>
              </a:xfrm>
            </p:grpSpPr>
            <p:pic>
              <p:nvPicPr>
                <p:cNvPr id="139" name="Picture 4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065240" y="2636640"/>
                  <a:ext cx="900360" cy="88668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40" name="直線コネクタ 436"/>
                <p:cNvSpPr/>
                <p:nvPr/>
              </p:nvSpPr>
              <p:spPr>
                <a:xfrm>
                  <a:off x="1514520" y="2770200"/>
                  <a:ext cx="118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直線コネクタ 437"/>
                <p:cNvSpPr/>
                <p:nvPr/>
              </p:nvSpPr>
              <p:spPr>
                <a:xfrm flipH="1">
                  <a:off x="1514160" y="2981520"/>
                  <a:ext cx="96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直線コネクタ 438"/>
                <p:cNvSpPr/>
                <p:nvPr/>
              </p:nvSpPr>
              <p:spPr>
                <a:xfrm>
                  <a:off x="1461960" y="3233880"/>
                  <a:ext cx="149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直線コネクタ 439"/>
                <p:cNvSpPr/>
                <p:nvPr/>
              </p:nvSpPr>
              <p:spPr>
                <a:xfrm flipH="1">
                  <a:off x="1514520" y="3432240"/>
                  <a:ext cx="64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4" name="グループ化 446"/>
              <p:cNvGrpSpPr/>
              <p:nvPr/>
            </p:nvGrpSpPr>
            <p:grpSpPr>
              <a:xfrm>
                <a:off x="1988280" y="2636640"/>
                <a:ext cx="900360" cy="886680"/>
                <a:chOff x="1988280" y="2636640"/>
                <a:chExt cx="900360" cy="886680"/>
              </a:xfrm>
            </p:grpSpPr>
            <p:pic>
              <p:nvPicPr>
                <p:cNvPr id="145" name="Picture 4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988280" y="2636640"/>
                  <a:ext cx="900360" cy="88668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46" name="直線コネクタ 442"/>
                <p:cNvSpPr/>
                <p:nvPr/>
              </p:nvSpPr>
              <p:spPr>
                <a:xfrm>
                  <a:off x="2406600" y="2770200"/>
                  <a:ext cx="106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直線コネクタ 443"/>
                <p:cNvSpPr/>
                <p:nvPr/>
              </p:nvSpPr>
              <p:spPr>
                <a:xfrm flipH="1">
                  <a:off x="2437920" y="2981520"/>
                  <a:ext cx="42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直線コネクタ 444"/>
                <p:cNvSpPr/>
                <p:nvPr/>
              </p:nvSpPr>
              <p:spPr>
                <a:xfrm>
                  <a:off x="2438280" y="3233880"/>
                  <a:ext cx="53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直線コネクタ 445"/>
                <p:cNvSpPr/>
                <p:nvPr/>
              </p:nvSpPr>
              <p:spPr>
                <a:xfrm flipH="1">
                  <a:off x="2363400" y="3432240"/>
                  <a:ext cx="745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0" name="グループ化 452"/>
              <p:cNvGrpSpPr/>
              <p:nvPr/>
            </p:nvGrpSpPr>
            <p:grpSpPr>
              <a:xfrm>
                <a:off x="2911320" y="2636640"/>
                <a:ext cx="900360" cy="886680"/>
                <a:chOff x="2911320" y="2636640"/>
                <a:chExt cx="900360" cy="886680"/>
              </a:xfrm>
            </p:grpSpPr>
            <p:pic>
              <p:nvPicPr>
                <p:cNvPr id="151" name="Picture 4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2911320" y="2636640"/>
                  <a:ext cx="900360" cy="88668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52" name="直線コネクタ 448"/>
                <p:cNvSpPr/>
                <p:nvPr/>
              </p:nvSpPr>
              <p:spPr>
                <a:xfrm>
                  <a:off x="3222360" y="2770200"/>
                  <a:ext cx="288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直線コネクタ 449"/>
                <p:cNvSpPr/>
                <p:nvPr/>
              </p:nvSpPr>
              <p:spPr>
                <a:xfrm flipH="1">
                  <a:off x="3222360" y="2981520"/>
                  <a:ext cx="311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直線コネクタ 450"/>
                <p:cNvSpPr/>
                <p:nvPr/>
              </p:nvSpPr>
              <p:spPr>
                <a:xfrm>
                  <a:off x="3200400" y="3233880"/>
                  <a:ext cx="365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直線コネクタ 451"/>
                <p:cNvSpPr/>
                <p:nvPr/>
              </p:nvSpPr>
              <p:spPr>
                <a:xfrm flipH="1">
                  <a:off x="3232080" y="3432240"/>
                  <a:ext cx="3016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6" name="グループ化 458"/>
              <p:cNvGrpSpPr/>
              <p:nvPr/>
            </p:nvGrpSpPr>
            <p:grpSpPr>
              <a:xfrm>
                <a:off x="3843000" y="2636640"/>
                <a:ext cx="900360" cy="886680"/>
                <a:chOff x="3843000" y="2636640"/>
                <a:chExt cx="900360" cy="886680"/>
              </a:xfrm>
            </p:grpSpPr>
            <p:pic>
              <p:nvPicPr>
                <p:cNvPr id="157" name="Picture 4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843000" y="2636640"/>
                  <a:ext cx="900360" cy="88668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58" name="直線コネクタ 454"/>
                <p:cNvSpPr/>
                <p:nvPr/>
              </p:nvSpPr>
              <p:spPr>
                <a:xfrm>
                  <a:off x="4143240" y="2770200"/>
                  <a:ext cx="311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直線コネクタ 455"/>
                <p:cNvSpPr/>
                <p:nvPr/>
              </p:nvSpPr>
              <p:spPr>
                <a:xfrm flipH="1">
                  <a:off x="4142880" y="2981520"/>
                  <a:ext cx="3538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直線コネクタ 456"/>
                <p:cNvSpPr/>
                <p:nvPr/>
              </p:nvSpPr>
              <p:spPr>
                <a:xfrm>
                  <a:off x="4109760" y="3233880"/>
                  <a:ext cx="3556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直線コネクタ 457"/>
                <p:cNvSpPr/>
                <p:nvPr/>
              </p:nvSpPr>
              <p:spPr>
                <a:xfrm flipH="1">
                  <a:off x="4132080" y="3432240"/>
                  <a:ext cx="387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62" name="Group 225"/>
            <p:cNvGrpSpPr/>
            <p:nvPr/>
          </p:nvGrpSpPr>
          <p:grpSpPr>
            <a:xfrm>
              <a:off x="1065240" y="3572640"/>
              <a:ext cx="3674880" cy="933480"/>
              <a:chOff x="1065240" y="3572640"/>
              <a:chExt cx="3674880" cy="933480"/>
            </a:xfrm>
          </p:grpSpPr>
          <p:grpSp>
            <p:nvGrpSpPr>
              <p:cNvPr id="163" name="グループ化 464"/>
              <p:cNvGrpSpPr/>
              <p:nvPr/>
            </p:nvGrpSpPr>
            <p:grpSpPr>
              <a:xfrm>
                <a:off x="1065240" y="3576960"/>
                <a:ext cx="900360" cy="929160"/>
                <a:chOff x="1065240" y="3576960"/>
                <a:chExt cx="900360" cy="929160"/>
              </a:xfrm>
            </p:grpSpPr>
            <p:pic>
              <p:nvPicPr>
                <p:cNvPr id="164" name="Picture 4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1065240" y="3576960"/>
                  <a:ext cx="900360" cy="92916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65" name="直線コネクタ 460"/>
                <p:cNvSpPr/>
                <p:nvPr/>
              </p:nvSpPr>
              <p:spPr>
                <a:xfrm>
                  <a:off x="1396800" y="3715920"/>
                  <a:ext cx="21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直線コネクタ 461"/>
                <p:cNvSpPr/>
                <p:nvPr/>
              </p:nvSpPr>
              <p:spPr>
                <a:xfrm flipH="1">
                  <a:off x="1419120" y="3922200"/>
                  <a:ext cx="203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直線コネクタ 462"/>
                <p:cNvSpPr/>
                <p:nvPr/>
              </p:nvSpPr>
              <p:spPr>
                <a:xfrm flipH="1">
                  <a:off x="1429920" y="4173120"/>
                  <a:ext cx="160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直線コネクタ 463"/>
                <p:cNvSpPr/>
                <p:nvPr/>
              </p:nvSpPr>
              <p:spPr>
                <a:xfrm flipH="1">
                  <a:off x="1407600" y="4396680"/>
                  <a:ext cx="21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9" name="グループ化 470"/>
              <p:cNvGrpSpPr/>
              <p:nvPr/>
            </p:nvGrpSpPr>
            <p:grpSpPr>
              <a:xfrm>
                <a:off x="1988280" y="3572640"/>
                <a:ext cx="900360" cy="929160"/>
                <a:chOff x="1988280" y="3572640"/>
                <a:chExt cx="900360" cy="929160"/>
              </a:xfrm>
            </p:grpSpPr>
            <p:pic>
              <p:nvPicPr>
                <p:cNvPr id="170" name="Picture 4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1988280" y="3572640"/>
                  <a:ext cx="900360" cy="92916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71" name="直線コネクタ 466"/>
                <p:cNvSpPr/>
                <p:nvPr/>
              </p:nvSpPr>
              <p:spPr>
                <a:xfrm>
                  <a:off x="2363760" y="3711600"/>
                  <a:ext cx="160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直線コネクタ 467"/>
                <p:cNvSpPr/>
                <p:nvPr/>
              </p:nvSpPr>
              <p:spPr>
                <a:xfrm flipH="1">
                  <a:off x="2341080" y="3917880"/>
                  <a:ext cx="2048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直線コネクタ 468"/>
                <p:cNvSpPr/>
                <p:nvPr/>
              </p:nvSpPr>
              <p:spPr>
                <a:xfrm flipH="1">
                  <a:off x="2352240" y="4168440"/>
                  <a:ext cx="214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直線コネクタ 469"/>
                <p:cNvSpPr/>
                <p:nvPr/>
              </p:nvSpPr>
              <p:spPr>
                <a:xfrm flipH="1">
                  <a:off x="2352600" y="4392360"/>
                  <a:ext cx="1936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5" name="グループ化 476"/>
              <p:cNvGrpSpPr/>
              <p:nvPr/>
            </p:nvGrpSpPr>
            <p:grpSpPr>
              <a:xfrm>
                <a:off x="2910960" y="3572640"/>
                <a:ext cx="900360" cy="929160"/>
                <a:chOff x="2910960" y="3572640"/>
                <a:chExt cx="900360" cy="929160"/>
              </a:xfrm>
            </p:grpSpPr>
            <p:pic>
              <p:nvPicPr>
                <p:cNvPr id="176" name="Picture 4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2910960" y="3572640"/>
                  <a:ext cx="900360" cy="92916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77" name="直線コネクタ 472"/>
                <p:cNvSpPr/>
                <p:nvPr/>
              </p:nvSpPr>
              <p:spPr>
                <a:xfrm>
                  <a:off x="3210840" y="3711600"/>
                  <a:ext cx="288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直線コネクタ 473"/>
                <p:cNvSpPr/>
                <p:nvPr/>
              </p:nvSpPr>
              <p:spPr>
                <a:xfrm flipH="1">
                  <a:off x="3210840" y="3917880"/>
                  <a:ext cx="311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直線コネクタ 474"/>
                <p:cNvSpPr/>
                <p:nvPr/>
              </p:nvSpPr>
              <p:spPr>
                <a:xfrm flipH="1">
                  <a:off x="3221640" y="4168440"/>
                  <a:ext cx="268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直線コネクタ 475"/>
                <p:cNvSpPr/>
                <p:nvPr/>
              </p:nvSpPr>
              <p:spPr>
                <a:xfrm flipH="1">
                  <a:off x="3210480" y="4392360"/>
                  <a:ext cx="268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1" name="グループ化 482"/>
              <p:cNvGrpSpPr/>
              <p:nvPr/>
            </p:nvGrpSpPr>
            <p:grpSpPr>
              <a:xfrm>
                <a:off x="3839760" y="3576960"/>
                <a:ext cx="900360" cy="929160"/>
                <a:chOff x="3839760" y="3576960"/>
                <a:chExt cx="900360" cy="929160"/>
              </a:xfrm>
            </p:grpSpPr>
            <p:pic>
              <p:nvPicPr>
                <p:cNvPr id="182" name="Picture 4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3839760" y="3576960"/>
                  <a:ext cx="900360" cy="929160"/>
                </a:xfrm>
                <a:prstGeom prst="rect">
                  <a:avLst/>
                </a:prstGeom>
                <a:ln w="9360">
                  <a:solidFill>
                    <a:srgbClr val="ffffff"/>
                  </a:solidFill>
                  <a:miter/>
                </a:ln>
              </p:spPr>
            </p:pic>
            <p:sp>
              <p:nvSpPr>
                <p:cNvPr id="183" name="直線コネクタ 478"/>
                <p:cNvSpPr/>
                <p:nvPr/>
              </p:nvSpPr>
              <p:spPr>
                <a:xfrm>
                  <a:off x="4182840" y="3715920"/>
                  <a:ext cx="2998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直線コネクタ 479"/>
                <p:cNvSpPr/>
                <p:nvPr/>
              </p:nvSpPr>
              <p:spPr>
                <a:xfrm flipH="1">
                  <a:off x="4140000" y="3922200"/>
                  <a:ext cx="3427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直線コネクタ 480"/>
                <p:cNvSpPr/>
                <p:nvPr/>
              </p:nvSpPr>
              <p:spPr>
                <a:xfrm flipH="1">
                  <a:off x="4160520" y="4173120"/>
                  <a:ext cx="3124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直線コネクタ 481"/>
                <p:cNvSpPr/>
                <p:nvPr/>
              </p:nvSpPr>
              <p:spPr>
                <a:xfrm flipH="1">
                  <a:off x="4160520" y="4396680"/>
                  <a:ext cx="3124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87" name="Rectangle 300"/>
            <p:cNvSpPr/>
            <p:nvPr/>
          </p:nvSpPr>
          <p:spPr>
            <a:xfrm>
              <a:off x="1065240" y="2636640"/>
              <a:ext cx="3672000" cy="18698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8" name="Group 318"/>
          <p:cNvGrpSpPr/>
          <p:nvPr/>
        </p:nvGrpSpPr>
        <p:grpSpPr>
          <a:xfrm>
            <a:off x="5169240" y="2206800"/>
            <a:ext cx="4544640" cy="2302920"/>
            <a:chOff x="5169240" y="2206800"/>
            <a:chExt cx="4544640" cy="2302920"/>
          </a:xfrm>
        </p:grpSpPr>
        <p:sp>
          <p:nvSpPr>
            <p:cNvPr id="189" name="Rectangle 327"/>
            <p:cNvSpPr/>
            <p:nvPr/>
          </p:nvSpPr>
          <p:spPr>
            <a:xfrm>
              <a:off x="5413320" y="2994120"/>
              <a:ext cx="366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C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330"/>
            <p:cNvSpPr/>
            <p:nvPr/>
          </p:nvSpPr>
          <p:spPr>
            <a:xfrm>
              <a:off x="5169240" y="3857760"/>
              <a:ext cx="610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DU14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436"/>
            <p:cNvSpPr/>
            <p:nvPr/>
          </p:nvSpPr>
          <p:spPr>
            <a:xfrm>
              <a:off x="8819280" y="231300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NP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442"/>
            <p:cNvSpPr/>
            <p:nvPr/>
          </p:nvSpPr>
          <p:spPr>
            <a:xfrm>
              <a:off x="7903080" y="2313000"/>
              <a:ext cx="854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r>
                <a:rPr b="1" i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PNP</a:t>
              </a: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448"/>
            <p:cNvSpPr/>
            <p:nvPr/>
          </p:nvSpPr>
          <p:spPr>
            <a:xfrm>
              <a:off x="7035120" y="2206800"/>
              <a:ext cx="747360" cy="42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si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448"/>
            <p:cNvSpPr/>
            <p:nvPr/>
          </p:nvSpPr>
          <p:spPr>
            <a:xfrm>
              <a:off x="6276240" y="2314440"/>
              <a:ext cx="427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575928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5" name="Group 307"/>
            <p:cNvGrpSpPr/>
            <p:nvPr/>
          </p:nvGrpSpPr>
          <p:grpSpPr>
            <a:xfrm>
              <a:off x="6032520" y="2638440"/>
              <a:ext cx="3671640" cy="863280"/>
              <a:chOff x="6032520" y="2638440"/>
              <a:chExt cx="3671640" cy="863280"/>
            </a:xfrm>
          </p:grpSpPr>
          <p:pic>
            <p:nvPicPr>
              <p:cNvPr id="196" name="Picture 68" descr="D:\Dr. kojima in chiba\kojima_invasion\PC3, DU145_miR-1, 133a_si-PNP_invasion\3.5.11_PC3_mock, miR-1, 133a, siC, siPNP-1, siPNP-3_invasion\P1010001.TIF"/>
              <p:cNvPicPr/>
              <p:nvPr/>
            </p:nvPicPr>
            <p:blipFill>
              <a:blip r:embed="rId9"/>
              <a:stretch/>
            </p:blipFill>
            <p:spPr>
              <a:xfrm>
                <a:off x="6032520" y="2638440"/>
                <a:ext cx="891000" cy="863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7" name="Picture 69" descr="D:\Dr. kojima in chiba\kojima_invasion\PC3, DU145_miR-1, 133a_si-PNP_invasion\3.5.11_PC3_mock, miR-1, 133a, siC, siPNP-1, siPNP-3_invasion\P1010010.TIF"/>
              <p:cNvPicPr/>
              <p:nvPr/>
            </p:nvPicPr>
            <p:blipFill>
              <a:blip r:embed="rId10"/>
              <a:stretch/>
            </p:blipFill>
            <p:spPr>
              <a:xfrm>
                <a:off x="6959880" y="2638440"/>
                <a:ext cx="891000" cy="863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8" name="Picture 71" descr="D:\Dr. kojima in chiba\kojima_invasion\PC3, DU145_miR-1, 133a_si-PNP_invasion\3.5.11_PC3_mock, miR-1, 133a, siC, siPNP-1, siPNP-3_invasion\P1010020.TIF"/>
              <p:cNvPicPr/>
              <p:nvPr/>
            </p:nvPicPr>
            <p:blipFill>
              <a:blip r:embed="rId11"/>
              <a:stretch/>
            </p:blipFill>
            <p:spPr>
              <a:xfrm>
                <a:off x="7885440" y="2638440"/>
                <a:ext cx="891360" cy="863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9" name="Picture 72" descr="D:\Dr. kojima in chiba\kojima_invasion\PC3, DU145_miR-1, 133a_si-PNP_invasion\3.5.11_PC3_mock, miR-1, 133a, siC, siPNP-1, siPNP-3_invasion\P1010025.TIF"/>
              <p:cNvPicPr/>
              <p:nvPr/>
            </p:nvPicPr>
            <p:blipFill>
              <a:blip r:embed="rId12"/>
              <a:stretch/>
            </p:blipFill>
            <p:spPr>
              <a:xfrm>
                <a:off x="8812800" y="2638440"/>
                <a:ext cx="891360" cy="86328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200" name="Picture 182" descr="D:\Dr. kojima in chiba\kojima_invasion\PC3, DU145_miR-1, 133a_si-PNP_invasion\3.6.11_DU145_mock, miR-1, 133a, siC, siPNP-1, siPNP-3_invasion\P1010004.TIF"/>
            <p:cNvPicPr/>
            <p:nvPr/>
          </p:nvPicPr>
          <p:blipFill>
            <a:blip r:embed="rId13"/>
            <a:stretch/>
          </p:blipFill>
          <p:spPr>
            <a:xfrm>
              <a:off x="6035760" y="3567240"/>
              <a:ext cx="890640" cy="93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1" name="Picture 183" descr="D:\Dr. kojima in chiba\kojima_invasion\PC3, DU145_miR-1, 133a_si-PNP_invasion\3.6.11_DU145_mock, miR-1, 133a, siC, siPNP-1, siPNP-3_invasion\P1010038.TIF"/>
            <p:cNvPicPr/>
            <p:nvPr/>
          </p:nvPicPr>
          <p:blipFill>
            <a:blip r:embed="rId14"/>
            <a:stretch/>
          </p:blipFill>
          <p:spPr>
            <a:xfrm>
              <a:off x="6953400" y="3567240"/>
              <a:ext cx="890280" cy="93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2" name="Picture 184" descr="D:\Dr. kojima in chiba\kojima_invasion\PC3, DU145_miR-1, 133a_si-PNP_invasion\3.6.11_DU145_mock, miR-1, 133a, siC, siPNP-1, siPNP-3_invasion\P1010047.TIF"/>
            <p:cNvPicPr/>
            <p:nvPr/>
          </p:nvPicPr>
          <p:blipFill>
            <a:blip r:embed="rId15"/>
            <a:stretch/>
          </p:blipFill>
          <p:spPr>
            <a:xfrm>
              <a:off x="7891560" y="3567240"/>
              <a:ext cx="888840" cy="93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3" name="Picture 185" descr="D:\Dr. kojima in chiba\kojima_invasion\PC3, DU145_miR-1, 133a_si-PNP_invasion\3.6.11_DU145_mock, miR-1, 133a, siC, siPNP-1, siPNP-3_invasion\P1010053.TIF"/>
            <p:cNvPicPr/>
            <p:nvPr/>
          </p:nvPicPr>
          <p:blipFill>
            <a:blip r:embed="rId16"/>
            <a:stretch/>
          </p:blipFill>
          <p:spPr>
            <a:xfrm>
              <a:off x="8823240" y="3567240"/>
              <a:ext cx="890640" cy="93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4" name="Rectangle 317"/>
            <p:cNvSpPr/>
            <p:nvPr/>
          </p:nvSpPr>
          <p:spPr>
            <a:xfrm>
              <a:off x="6033960" y="2638440"/>
              <a:ext cx="3672000" cy="1871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5" name="Text Box 197"/>
          <p:cNvSpPr/>
          <p:nvPr/>
        </p:nvSpPr>
        <p:spPr>
          <a:xfrm>
            <a:off x="277560" y="183816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97"/>
          <p:cNvSpPr/>
          <p:nvPr/>
        </p:nvSpPr>
        <p:spPr>
          <a:xfrm>
            <a:off x="5146560" y="1838160"/>
            <a:ext cx="31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0T04:11:34Z</dcterms:created>
  <dc:creator>Functional Genomics</dc:creator>
  <dc:description/>
  <dc:language>en-US</dc:language>
  <cp:lastModifiedBy>Nijiro Nohata</cp:lastModifiedBy>
  <dcterms:modified xsi:type="dcterms:W3CDTF">2011-10-14T06:33:47Z</dcterms:modified>
  <cp:revision>76</cp:revision>
  <dc:subject/>
  <dc:title>スライド 1</dc:title>
</cp:coreProperties>
</file>